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15"/>
  </p:normalViewPr>
  <p:slideViewPr>
    <p:cSldViewPr snapToGrid="0">
      <p:cViewPr>
        <p:scale>
          <a:sx n="125" d="100"/>
          <a:sy n="125" d="100"/>
        </p:scale>
        <p:origin x="21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8042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537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4816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665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7281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6740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6151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3160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4691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1307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0917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E26F8B-FC45-40BB-98AE-9420416E9DFD}" type="datetimeFigureOut">
              <a:rPr lang="en-GB" smtClean="0"/>
              <a:t>27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4986D-F692-4670-815A-9A04B64E03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7202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3F97B865-F02B-2F4E-8913-59037FDE6F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3337035"/>
              </p:ext>
            </p:extLst>
          </p:nvPr>
        </p:nvGraphicFramePr>
        <p:xfrm>
          <a:off x="134911" y="3110459"/>
          <a:ext cx="6592464" cy="2835683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4111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78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9479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6247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897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3824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0323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3249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3249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02228">
                <a:tc rowSpan="2">
                  <a:txBody>
                    <a:bodyPr/>
                    <a:lstStyle/>
                    <a:p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</a:p>
                  </a:txBody>
                  <a:tcPr anchor="b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ndard deviation</a:t>
                      </a:r>
                    </a:p>
                  </a:txBody>
                  <a:tcPr anchor="b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ld</a:t>
                      </a:r>
                    </a:p>
                  </a:txBody>
                  <a:tcPr anchor="b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grees</a:t>
                      </a:r>
                      <a:r>
                        <a:rPr lang="en-GB" sz="800" b="1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freedom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</a:p>
                  </a:txBody>
                  <a:tcPr anchor="b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GB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</a:t>
                      </a:r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B)</a:t>
                      </a:r>
                    </a:p>
                  </a:txBody>
                  <a:tcPr anchor="b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0 % CI for Exp (B)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GB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9122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wer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pper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121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ur-infiltrating lymphocytes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22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44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9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8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6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5948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O3_nuc_multiply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6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25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7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4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5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3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121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K_multiply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0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9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7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4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121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logic grade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5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19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8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13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3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99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121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5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2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88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8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68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4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75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21218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b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N_metastasis</a:t>
                      </a:r>
                      <a:endParaRPr lang="en-GB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8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0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07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79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83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7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45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72106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</a:pPr>
                      <a:r>
                        <a:rPr lang="en-GB" sz="8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XO3_cyto_multiply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003</a:t>
                      </a:r>
                    </a:p>
                  </a:txBody>
                  <a:tcPr anchor="ctr">
                    <a:lnL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3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3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7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9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4</a:t>
                      </a:r>
                    </a:p>
                  </a:txBody>
                  <a:tcPr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4CA5659B-D945-8447-B747-122242DA37E9}"/>
              </a:ext>
            </a:extLst>
          </p:cNvPr>
          <p:cNvSpPr txBox="1"/>
          <p:nvPr/>
        </p:nvSpPr>
        <p:spPr>
          <a:xfrm>
            <a:off x="-23017" y="14634"/>
            <a:ext cx="2206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pplementary Fig. S8</a:t>
            </a:r>
          </a:p>
        </p:txBody>
      </p:sp>
    </p:spTree>
    <p:extLst>
      <p:ext uri="{BB962C8B-B14F-4D97-AF65-F5344CB8AC3E}">
        <p14:creationId xmlns:p14="http://schemas.microsoft.com/office/powerpoint/2010/main" val="18316105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7</TotalTime>
  <Words>107</Words>
  <Application>Microsoft Macintosh PowerPoint</Application>
  <PresentationFormat>Widescreen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mud, Zimam</dc:creator>
  <cp:lastModifiedBy>Lam, Eric W</cp:lastModifiedBy>
  <cp:revision>22</cp:revision>
  <dcterms:created xsi:type="dcterms:W3CDTF">2019-05-29T06:58:03Z</dcterms:created>
  <dcterms:modified xsi:type="dcterms:W3CDTF">2019-06-27T19:58:21Z</dcterms:modified>
</cp:coreProperties>
</file>